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B46F52-DC69-48E3-9597-3FDB764493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E1AE9-FE6F-48E9-A720-1C85364CC5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274F3-8F92-4893-B7C4-23D7E06D9B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8927AA-127D-4882-800F-C7458D59B2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2A153-86DE-4472-83B1-FC190DB641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87CB5-E829-4C8B-8879-9443F8B3C9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98230-2499-4E72-BD40-E87E4EC7FD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9F0F0A-A149-4819-8E75-44E7254E3D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F344A-70A2-4790-AE81-E3C1454343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6D2FA-76BD-476D-BD29-53C0F87D70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AD034-984A-4F76-97D4-3CDFF4FB54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87AA1B-D952-4D42-B2A8-526C5D1155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19840F-7FA9-459F-84CA-1DF073260A28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973160" y="2082960"/>
            <a:ext cx="109800" cy="293040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097000" y="4938840"/>
            <a:ext cx="109800" cy="7452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316240" y="2090880"/>
            <a:ext cx="109440" cy="292248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657520" y="2300400"/>
            <a:ext cx="109440" cy="271296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781360" y="4976640"/>
            <a:ext cx="109440" cy="3672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000240" y="3790800"/>
            <a:ext cx="115920" cy="122256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344760" y="3832200"/>
            <a:ext cx="109800" cy="118116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468600" y="4944960"/>
            <a:ext cx="109800" cy="6840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87840" y="3994200"/>
            <a:ext cx="109440" cy="101916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811680" y="5006880"/>
            <a:ext cx="109440" cy="648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030560" y="4071960"/>
            <a:ext cx="109800" cy="94140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152960" y="4952880"/>
            <a:ext cx="115920" cy="6048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375080" y="4202280"/>
            <a:ext cx="109440" cy="81108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494240" y="4986360"/>
            <a:ext cx="109440" cy="2700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692600" y="4311720"/>
            <a:ext cx="111240" cy="70164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816440" y="4976640"/>
            <a:ext cx="109440" cy="3672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035680" y="4979880"/>
            <a:ext cx="109440" cy="3348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378400" y="4994280"/>
            <a:ext cx="109440" cy="1908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502240" y="4991040"/>
            <a:ext cx="111240" cy="2232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7094520" y="4935600"/>
            <a:ext cx="109440" cy="7776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7215120" y="4935600"/>
            <a:ext cx="109440" cy="77760"/>
          </a:xfrm>
          <a:prstGeom prst="rect">
            <a:avLst/>
          </a:prstGeom>
          <a:solidFill>
            <a:srgbClr val="bbe0e3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2027160" y="1974960"/>
            <a:ext cx="1800" cy="10296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969920" y="1974960"/>
            <a:ext cx="10800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2139840" y="4911480"/>
            <a:ext cx="1800" cy="2196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093760" y="4911840"/>
            <a:ext cx="1080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2368440" y="1938240"/>
            <a:ext cx="1800" cy="1476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313000" y="1938240"/>
            <a:ext cx="108000" cy="18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436840" y="4997520"/>
            <a:ext cx="1080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V="1">
            <a:off x="2711520" y="1920960"/>
            <a:ext cx="1440" cy="3744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655720" y="1920960"/>
            <a:ext cx="10332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>
            <a:off x="2832120" y="4944600"/>
            <a:ext cx="1440" cy="2700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779560" y="4941720"/>
            <a:ext cx="103320" cy="180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V="1">
            <a:off x="3049560" y="3750840"/>
            <a:ext cx="1440" cy="3492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997360" y="3751200"/>
            <a:ext cx="107640" cy="18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152880" y="4994280"/>
            <a:ext cx="144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130560" y="4998960"/>
            <a:ext cx="108000" cy="180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3395520" y="3787920"/>
            <a:ext cx="1800" cy="396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0" bIns="-7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340080" y="3787920"/>
            <a:ext cx="10800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3519360" y="4908600"/>
            <a:ext cx="1800" cy="3168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468600" y="4908600"/>
            <a:ext cx="1080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3738600" y="3939840"/>
            <a:ext cx="1440" cy="4932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683160" y="3940200"/>
            <a:ext cx="10296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3838680" y="4997160"/>
            <a:ext cx="1440" cy="468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807000" y="4997520"/>
            <a:ext cx="10296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 flipV="1">
            <a:off x="4081320" y="4022640"/>
            <a:ext cx="1800" cy="446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024440" y="4022640"/>
            <a:ext cx="108000" cy="18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4202280" y="4930560"/>
            <a:ext cx="1440" cy="2196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4151160" y="4923000"/>
            <a:ext cx="10332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V="1">
            <a:off x="4427640" y="4133880"/>
            <a:ext cx="1440" cy="6336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4371840" y="4133880"/>
            <a:ext cx="10800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4522680" y="4975200"/>
            <a:ext cx="1800" cy="648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4491000" y="4975200"/>
            <a:ext cx="1080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V="1">
            <a:off x="4746600" y="4116240"/>
            <a:ext cx="1440" cy="1908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691160" y="4113360"/>
            <a:ext cx="10296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4865760" y="4954680"/>
            <a:ext cx="1440" cy="1728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4815000" y="4951440"/>
            <a:ext cx="10296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flipV="1">
            <a:off x="5084640" y="4959360"/>
            <a:ext cx="1800" cy="158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033880" y="4959360"/>
            <a:ext cx="10332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160960" y="4997520"/>
            <a:ext cx="1080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5407200" y="4986000"/>
            <a:ext cx="1440" cy="32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375160" y="4983120"/>
            <a:ext cx="108000" cy="18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5530680" y="4981320"/>
            <a:ext cx="1800" cy="468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2120" bIns="-421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499000" y="4981680"/>
            <a:ext cx="1080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5749920" y="4990680"/>
            <a:ext cx="1440" cy="32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5718240" y="4992840"/>
            <a:ext cx="10800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5861160" y="5000760"/>
            <a:ext cx="144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829480" y="5000760"/>
            <a:ext cx="10296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6060960" y="4997520"/>
            <a:ext cx="10332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6203880" y="5000760"/>
            <a:ext cx="18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6172200" y="5000760"/>
            <a:ext cx="108000" cy="144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6402240" y="4997520"/>
            <a:ext cx="108000" cy="144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546960" y="4998960"/>
            <a:ext cx="1440" cy="180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6515280" y="4998960"/>
            <a:ext cx="107640" cy="180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778800" y="4998960"/>
            <a:ext cx="1440" cy="18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746760" y="4998960"/>
            <a:ext cx="108000" cy="1800"/>
          </a:xfrm>
          <a:prstGeom prst="line">
            <a:avLst/>
          </a:prstGeom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899400" y="4998960"/>
            <a:ext cx="1440" cy="180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6867360" y="4998960"/>
            <a:ext cx="103320" cy="1800"/>
          </a:xfrm>
          <a:prstGeom prst="line">
            <a:avLst/>
          </a:prstGeom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706400" y="461808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706400" y="421956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706400" y="382284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706400" y="342432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706400" y="263052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706400" y="223200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706400" y="183528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706400" y="1440000"/>
            <a:ext cx="270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512360" y="49640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512360" y="4567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441440" y="41688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441440" y="377208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441440" y="33735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441440" y="258120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441440" y="21812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1441440" y="17859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441440" y="138924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441440" y="9907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1701720" y="1017720"/>
            <a:ext cx="5918400" cy="39988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8574200">
            <a:off x="1596240" y="5204880"/>
            <a:ext cx="65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METTL7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 rot="18581400">
            <a:off x="2037240" y="5159520"/>
            <a:ext cx="53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PLAU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rot="18591600">
            <a:off x="2410200" y="5154480"/>
            <a:ext cx="52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PNR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 rot="18594600">
            <a:off x="2857680" y="5087880"/>
            <a:ext cx="35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I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rot="18573600">
            <a:off x="3128760" y="5127840"/>
            <a:ext cx="462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GUK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 rot="18579600">
            <a:off x="3409560" y="5166360"/>
            <a:ext cx="56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QRICH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rot="18579600">
            <a:off x="3798000" y="5169600"/>
            <a:ext cx="56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IMPDH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 rot="18585600">
            <a:off x="4099320" y="515556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ARL4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 rot="18573600">
            <a:off x="4472640" y="513144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2703"/>
                </a:solidFill>
                <a:latin typeface="Arial"/>
              </a:rPr>
              <a:t>PC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 rot="18577800">
            <a:off x="4850280" y="512676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229ff"/>
                </a:solidFill>
                <a:latin typeface="Arial"/>
              </a:rPr>
              <a:t>DAZ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rot="18585000">
            <a:off x="5187600" y="513108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229ff"/>
                </a:solidFill>
                <a:latin typeface="Arial"/>
              </a:rPr>
              <a:t>DN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 rot="18572400">
            <a:off x="5460480" y="5197320"/>
            <a:ext cx="63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229ff"/>
                </a:solidFill>
                <a:latin typeface="Arial"/>
              </a:rPr>
              <a:t>TBC1D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 rot="18583800">
            <a:off x="5847120" y="516564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229ff"/>
                </a:solidFill>
                <a:latin typeface="Arial"/>
              </a:rPr>
              <a:t>DIRAS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 rot="18580200">
            <a:off x="6170040" y="5174640"/>
            <a:ext cx="57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229ff"/>
                </a:solidFill>
                <a:latin typeface="Arial"/>
              </a:rPr>
              <a:t>SLC4A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 rot="18591600">
            <a:off x="6572520" y="5154120"/>
            <a:ext cx="52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229ff"/>
                </a:solidFill>
                <a:latin typeface="Arial"/>
              </a:rPr>
              <a:t>NRXN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 rot="18576600">
            <a:off x="6894000" y="5158440"/>
            <a:ext cx="54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29a32"/>
                </a:solidFill>
                <a:latin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600200" y="3016080"/>
            <a:ext cx="1371600" cy="135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5829480" y="1849320"/>
            <a:ext cx="237960" cy="244440"/>
          </a:xfrm>
          <a:prstGeom prst="rect">
            <a:avLst/>
          </a:prstGeom>
          <a:solidFill>
            <a:srgbClr val="ff870f"/>
          </a:solidFill>
          <a:ln w="12600">
            <a:solidFill>
              <a:srgbClr val="ff870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5829480" y="2214720"/>
            <a:ext cx="237960" cy="244440"/>
          </a:xfrm>
          <a:prstGeom prst="rect">
            <a:avLst/>
          </a:prstGeom>
          <a:solidFill>
            <a:srgbClr val="63aafe"/>
          </a:solidFill>
          <a:ln w="12600">
            <a:solidFill>
              <a:srgbClr val="4652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2666880" y="5759280"/>
            <a:ext cx="99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>
                <a:solidFill>
                  <a:srgbClr val="ff2703"/>
                </a:solidFill>
                <a:latin typeface="Arial"/>
              </a:rPr>
              <a:t>Enriched regions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>
                <a:solidFill>
                  <a:srgbClr val="ff2703"/>
                </a:solidFill>
                <a:latin typeface="Arial"/>
              </a:rPr>
              <a:t>( p-value &lt; 1e-6 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5334120" y="5759280"/>
            <a:ext cx="1143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>
                <a:solidFill>
                  <a:srgbClr val="1229ff"/>
                </a:solidFill>
                <a:latin typeface="Arial"/>
              </a:rPr>
              <a:t>Non-enriched regions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700" spc="-1" strike="noStrike">
                <a:solidFill>
                  <a:srgbClr val="1229ff"/>
                </a:solidFill>
                <a:latin typeface="Arial"/>
              </a:rPr>
              <a:t>( p-value &gt; 1e-3 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 rot="16200000">
            <a:off x="-93960" y="2401920"/>
            <a:ext cx="216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lative Fold Enrich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6094440" y="1855800"/>
            <a:ext cx="7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G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6094440" y="22208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Normal I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644480" y="3151080"/>
            <a:ext cx="121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1644480" y="3014640"/>
            <a:ext cx="1219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708200" y="5678640"/>
            <a:ext cx="2971800" cy="0"/>
          </a:xfrm>
          <a:prstGeom prst="line">
            <a:avLst/>
          </a:prstGeom>
          <a:ln w="28440">
            <a:solidFill>
              <a:srgbClr val="ff270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876920" y="5678640"/>
            <a:ext cx="1981080" cy="0"/>
          </a:xfrm>
          <a:prstGeom prst="line">
            <a:avLst/>
          </a:prstGeom>
          <a:ln w="28440">
            <a:solidFill>
              <a:srgbClr val="1229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7315200" y="6496200"/>
            <a:ext cx="17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Additional data file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1T07:49:29Z</dcterms:created>
  <dc:creator>Kubosaki</dc:creator>
  <dc:description/>
  <dc:language>en-US</dc:language>
  <cp:lastModifiedBy>Kubosaki</cp:lastModifiedBy>
  <cp:lastPrinted>2009-04-03T03:25:53Z</cp:lastPrinted>
  <dcterms:modified xsi:type="dcterms:W3CDTF">2009-04-03T03:25:55Z</dcterms:modified>
  <cp:revision>6</cp:revision>
  <dc:subject/>
  <dc:title>PowerPoint プレゼンテーション</dc:title>
</cp:coreProperties>
</file>